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9" d="100"/>
          <a:sy n="89" d="100"/>
        </p:scale>
        <p:origin x="-76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mhall:Desktop:Zygiel%20Paper:Figures:ZygielPaper-Figs2B+3B%20(bar%20graphs)-Revisio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I$417:$I$422</c:f>
                <c:numCache>
                  <c:formatCode>General</c:formatCode>
                  <c:ptCount val="6"/>
                  <c:pt idx="0">
                    <c:v>0.108029186109141</c:v>
                  </c:pt>
                  <c:pt idx="1">
                    <c:v>0.130426876289054</c:v>
                  </c:pt>
                  <c:pt idx="2">
                    <c:v>0.134094430101268</c:v>
                  </c:pt>
                  <c:pt idx="3">
                    <c:v>0.0853481427910549</c:v>
                  </c:pt>
                  <c:pt idx="4">
                    <c:v>0.150711446900827</c:v>
                  </c:pt>
                  <c:pt idx="5">
                    <c:v>0.112675813763744</c:v>
                  </c:pt>
                </c:numCache>
              </c:numRef>
            </c:plus>
            <c:minus>
              <c:numRef>
                <c:f>Sheet1!$I$417:$I$422</c:f>
                <c:numCache>
                  <c:formatCode>General</c:formatCode>
                  <c:ptCount val="6"/>
                  <c:pt idx="0">
                    <c:v>0.108029186109141</c:v>
                  </c:pt>
                  <c:pt idx="1">
                    <c:v>0.130426876289054</c:v>
                  </c:pt>
                  <c:pt idx="2">
                    <c:v>0.134094430101268</c:v>
                  </c:pt>
                  <c:pt idx="3">
                    <c:v>0.0853481427910549</c:v>
                  </c:pt>
                  <c:pt idx="4">
                    <c:v>0.150711446900827</c:v>
                  </c:pt>
                  <c:pt idx="5">
                    <c:v>0.112675813763744</c:v>
                  </c:pt>
                </c:numCache>
              </c:numRef>
            </c:minus>
          </c:errBars>
          <c:cat>
            <c:strRef>
              <c:f>Sheet1!$A$417:$A$422</c:f>
              <c:strCache>
                <c:ptCount val="6"/>
                <c:pt idx="0">
                  <c:v>WT-M13</c:v>
                </c:pt>
                <c:pt idx="1">
                  <c:v>M13KE</c:v>
                </c:pt>
                <c:pt idx="2">
                  <c:v>ACX5CX1 Library</c:v>
                </c:pt>
                <c:pt idx="3">
                  <c:v>ΔlacZα-827 from ACX5CX1 Library</c:v>
                </c:pt>
                <c:pt idx="4">
                  <c:v>ACX6C Library</c:v>
                </c:pt>
                <c:pt idx="5">
                  <c:v>ΔlacZα-827 from ACX6C Library</c:v>
                </c:pt>
              </c:strCache>
            </c:strRef>
          </c:cat>
          <c:val>
            <c:numRef>
              <c:f>Sheet1!$G$417:$G$422</c:f>
              <c:numCache>
                <c:formatCode>0.00</c:formatCode>
                <c:ptCount val="6"/>
                <c:pt idx="0">
                  <c:v>7.59164136338823</c:v>
                </c:pt>
                <c:pt idx="1">
                  <c:v>5.337799263346661</c:v>
                </c:pt>
                <c:pt idx="2">
                  <c:v>5.299675726090814</c:v>
                </c:pt>
                <c:pt idx="3">
                  <c:v>7.604203990622578</c:v>
                </c:pt>
                <c:pt idx="4">
                  <c:v>5.94916275164684</c:v>
                </c:pt>
                <c:pt idx="5">
                  <c:v>7.7601441186307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7893032"/>
        <c:axId val="-2117890904"/>
      </c:barChart>
      <c:catAx>
        <c:axId val="-2117893032"/>
        <c:scaling>
          <c:orientation val="minMax"/>
        </c:scaling>
        <c:delete val="0"/>
        <c:axPos val="b"/>
        <c:majorTickMark val="out"/>
        <c:minorTickMark val="none"/>
        <c:tickLblPos val="nextTo"/>
        <c:crossAx val="-2117890904"/>
        <c:crosses val="autoZero"/>
        <c:auto val="1"/>
        <c:lblAlgn val="ctr"/>
        <c:lblOffset val="100"/>
        <c:noMultiLvlLbl val="0"/>
      </c:catAx>
      <c:valAx>
        <c:axId val="-2117890904"/>
        <c:scaling>
          <c:orientation val="minMax"/>
          <c:max val="8.0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log(pfu/uL)</a:t>
                </a:r>
              </a:p>
            </c:rich>
          </c:tx>
          <c:layout>
            <c:manualLayout>
              <c:xMode val="edge"/>
              <c:yMode val="edge"/>
              <c:x val="0.0192838868466839"/>
              <c:y val="0.392008183387264"/>
            </c:manualLayout>
          </c:layout>
          <c:overlay val="0"/>
        </c:title>
        <c:numFmt formatCode="0" sourceLinked="0"/>
        <c:majorTickMark val="out"/>
        <c:minorTickMark val="in"/>
        <c:tickLblPos val="nextTo"/>
        <c:crossAx val="-2117893032"/>
        <c:crosses val="autoZero"/>
        <c:crossBetween val="between"/>
        <c:minorUnit val="0.1"/>
      </c:valAx>
    </c:plotArea>
    <c:plotVisOnly val="1"/>
    <c:dispBlanksAs val="gap"/>
    <c:showDLblsOverMax val="0"/>
  </c:chart>
  <c:txPr>
    <a:bodyPr/>
    <a:lstStyle/>
    <a:p>
      <a:pPr>
        <a:defRPr sz="12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867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8261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693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580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041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357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312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442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315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109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414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C723B6-0F99-A241-9C99-DBC3876F5FA3}" type="datetimeFigureOut">
              <a:rPr lang="en-US" smtClean="0"/>
              <a:t>3/2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EF5D00-416C-5D4C-B8A6-F1393286CC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36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 noGrp="1"/>
          </p:cNvGraphicFramePr>
          <p:nvPr/>
        </p:nvGraphicFramePr>
        <p:xfrm>
          <a:off x="291224" y="516758"/>
          <a:ext cx="8561552" cy="58244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098955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>Stonehill College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Information Technology</dc:creator>
  <cp:keywords/>
  <dc:description/>
  <cp:lastModifiedBy>Information Technology</cp:lastModifiedBy>
  <cp:revision>2</cp:revision>
  <dcterms:created xsi:type="dcterms:W3CDTF">2017-03-27T12:54:31Z</dcterms:created>
  <dcterms:modified xsi:type="dcterms:W3CDTF">2017-03-28T16:13:47Z</dcterms:modified>
  <cp:category/>
</cp:coreProperties>
</file>